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2478" y="1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536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106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966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9981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675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802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138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0551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3784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8601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696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C0278-A0F5-429A-8100-07504353F2AF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6E1376-F3C1-4ED4-9384-7871E949C6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1295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B45CF804-C6C0-5609-B7E7-E45A64766A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74711"/>
            <a:ext cx="18473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5" name="图片 1">
            <a:extLst>
              <a:ext uri="{FF2B5EF4-FFF2-40B4-BE49-F238E27FC236}">
                <a16:creationId xmlns:a16="http://schemas.microsoft.com/office/drawing/2014/main" id="{DE28EE59-E331-C3B7-BDE0-8FFF5812CE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2600" y="382488"/>
            <a:ext cx="5346700" cy="5014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04B5F491-3751-74F9-5C2C-FDFC78A4D0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900" y="5658227"/>
            <a:ext cx="7912099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30480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. </a:t>
            </a:r>
            <a:r>
              <a:rPr kumimoji="0" lang="en-US" altLang="zh-CN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analysis revealing the consistency between the RNA sequencing and qRT-PCR data. The RNA sequencing data (x-axis) were plotted against the qRT-PCR data (y-axis).</a:t>
            </a:r>
            <a:endParaRPr kumimoji="0" lang="en-US" altLang="zh-CN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1091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</TotalTime>
  <Words>33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靖欣 霍</dc:creator>
  <cp:lastModifiedBy>靖欣 霍</cp:lastModifiedBy>
  <cp:revision>1</cp:revision>
  <dcterms:created xsi:type="dcterms:W3CDTF">2024-05-29T17:19:09Z</dcterms:created>
  <dcterms:modified xsi:type="dcterms:W3CDTF">2024-05-29T17:21:13Z</dcterms:modified>
</cp:coreProperties>
</file>